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81" r:id="rId3"/>
    <p:sldId id="258" r:id="rId4"/>
    <p:sldId id="259" r:id="rId5"/>
    <p:sldId id="260" r:id="rId6"/>
    <p:sldId id="268" r:id="rId7"/>
    <p:sldId id="267" r:id="rId8"/>
    <p:sldId id="265" r:id="rId9"/>
    <p:sldId id="266" r:id="rId10"/>
    <p:sldId id="263" r:id="rId11"/>
    <p:sldId id="264" r:id="rId12"/>
    <p:sldId id="279" r:id="rId13"/>
    <p:sldId id="278" r:id="rId14"/>
    <p:sldId id="277" r:id="rId15"/>
    <p:sldId id="276" r:id="rId16"/>
    <p:sldId id="275" r:id="rId17"/>
    <p:sldId id="274" r:id="rId18"/>
    <p:sldId id="273" r:id="rId19"/>
    <p:sldId id="272" r:id="rId20"/>
    <p:sldId id="271" r:id="rId21"/>
    <p:sldId id="270" r:id="rId22"/>
    <p:sldId id="269" r:id="rId23"/>
    <p:sldId id="261" r:id="rId24"/>
    <p:sldId id="262" r:id="rId25"/>
    <p:sldId id="280" r:id="rId26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3" d="100"/>
          <a:sy n="103" d="100"/>
        </p:scale>
        <p:origin x="-20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viewProps" Target="view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presProps" Target="presProps.xml"/><Relationship Id="rId30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754903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1022854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558482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6884936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769682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132619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9770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619103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99459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236175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4406611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7F884FA-7E72-4ECE-ADF3-D7A262F0A011}" type="datetimeFigureOut">
              <a:rPr lang="en-US" smtClean="0"/>
              <a:t>12/8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6D1EC34-6811-4716-BA3A-ED472E6398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00028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emf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slideLayout" Target="../slideLayouts/slideLayout1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emf"/><Relationship Id="rId1" Type="http://schemas.openxmlformats.org/officeDocument/2006/relationships/slideLayout" Target="../slideLayouts/slideLayout1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slideLayout" Target="../slideLayouts/slideLayout1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emf"/><Relationship Id="rId1" Type="http://schemas.openxmlformats.org/officeDocument/2006/relationships/slideLayout" Target="../slideLayouts/slideLayout1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emf"/><Relationship Id="rId1" Type="http://schemas.openxmlformats.org/officeDocument/2006/relationships/slideLayout" Target="../slideLayouts/slideLayout1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emf"/><Relationship Id="rId1" Type="http://schemas.openxmlformats.org/officeDocument/2006/relationships/slideLayout" Target="../slideLayouts/slideLayout1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emf"/><Relationship Id="rId1" Type="http://schemas.openxmlformats.org/officeDocument/2006/relationships/slideLayout" Target="../slideLayouts/slideLayout1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em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emf"/><Relationship Id="rId1" Type="http://schemas.openxmlformats.org/officeDocument/2006/relationships/slideLayout" Target="../slideLayouts/slideLayout1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emf"/><Relationship Id="rId1" Type="http://schemas.openxmlformats.org/officeDocument/2006/relationships/slideLayout" Target="../slideLayouts/slideLayout1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emf"/><Relationship Id="rId1" Type="http://schemas.openxmlformats.org/officeDocument/2006/relationships/slideLayout" Target="../slideLayouts/slideLayout1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1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emf"/><Relationship Id="rId1" Type="http://schemas.openxmlformats.org/officeDocument/2006/relationships/slideLayout" Target="../slideLayouts/slideLayout1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emf"/><Relationship Id="rId1" Type="http://schemas.openxmlformats.org/officeDocument/2006/relationships/slideLayout" Target="../slideLayouts/slideLayout1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emf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em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em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em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em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em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em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0" y="1524000"/>
            <a:ext cx="5364163" cy="646113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sp>
        <p:nvSpPr>
          <p:cNvPr id="3" name="TextBox 2"/>
          <p:cNvSpPr txBox="1"/>
          <p:nvPr/>
        </p:nvSpPr>
        <p:spPr>
          <a:xfrm>
            <a:off x="1981200" y="2590800"/>
            <a:ext cx="41629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Location </a:t>
            </a:r>
            <a:r>
              <a:rPr lang="en-US" smtClean="0"/>
              <a:t>of INR </a:t>
            </a:r>
            <a:r>
              <a:rPr lang="en-US" dirty="0" smtClean="0"/>
              <a:t>Elements in All Promoters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3875698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51025" y="590550"/>
            <a:ext cx="5440363" cy="56800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83395793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5950" y="561975"/>
            <a:ext cx="5370513" cy="57372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73753345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51025" y="561975"/>
            <a:ext cx="5440363" cy="57372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1158468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2450" y="525463"/>
            <a:ext cx="5499100" cy="58118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4927534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9750"/>
            <a:ext cx="5413375" cy="57816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6186529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9750"/>
            <a:ext cx="5413375" cy="57816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6269683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49275"/>
            <a:ext cx="5411787" cy="5762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4324410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2450" y="549275"/>
            <a:ext cx="5497513" cy="5762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63625102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2450" y="544513"/>
            <a:ext cx="5497513" cy="5772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736027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19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44513"/>
            <a:ext cx="5411787" cy="57721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97523882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70075" y="533400"/>
            <a:ext cx="5402263" cy="57943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446958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17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452438"/>
            <a:ext cx="5413375" cy="59578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10200311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14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524000" y="152400"/>
            <a:ext cx="5413375" cy="62611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8429882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4988"/>
            <a:ext cx="5413375" cy="5791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3894919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41338"/>
            <a:ext cx="5411787" cy="578008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9762057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68325"/>
            <a:ext cx="5411787" cy="57245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81430645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34988"/>
            <a:ext cx="5413375" cy="579120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9273064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3" y="549275"/>
            <a:ext cx="5411787" cy="576262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3595231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2450" y="544513"/>
            <a:ext cx="5497513" cy="57737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802651609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074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57375" y="538163"/>
            <a:ext cx="5429250" cy="5784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350162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098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85950" y="576263"/>
            <a:ext cx="5370513" cy="57102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143760240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122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2450" y="525463"/>
            <a:ext cx="5499100" cy="5811837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20431030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22450" y="514350"/>
            <a:ext cx="5497513" cy="5832475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19301293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050" name="Picture 2"/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865311" y="152400"/>
            <a:ext cx="5271257" cy="6476999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</p:spTree>
    <p:extLst>
      <p:ext uri="{BB962C8B-B14F-4D97-AF65-F5344CB8AC3E}">
        <p14:creationId xmlns:p14="http://schemas.microsoft.com/office/powerpoint/2010/main" val="427897605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37</TotalTime>
  <Words>7</Words>
  <Application>Microsoft Office PowerPoint</Application>
  <PresentationFormat>On-screen Show (4:3)</PresentationFormat>
  <Paragraphs>1</Paragraphs>
  <Slides>25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25</vt:i4>
      </vt:variant>
    </vt:vector>
  </HeadingPairs>
  <TitlesOfParts>
    <vt:vector size="26" baseType="lpstr"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y Brown</dc:creator>
  <cp:lastModifiedBy>Jay Brown</cp:lastModifiedBy>
  <cp:revision>69</cp:revision>
  <dcterms:created xsi:type="dcterms:W3CDTF">2017-07-17T14:27:03Z</dcterms:created>
  <dcterms:modified xsi:type="dcterms:W3CDTF">2017-12-08T14:44:41Z</dcterms:modified>
</cp:coreProperties>
</file>